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8" r:id="rId4"/>
    <p:sldId id="269" r:id="rId5"/>
    <p:sldId id="270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9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hang, C. (Congrou)" userId="0c54211a-fdd0-48db-9439-148c878f923c" providerId="ADAL" clId="{B3918507-D423-4401-9C73-489D4DF24825}"/>
    <pc:docChg chg="undo custSel modSld">
      <pc:chgData name="Zhang, C. (Congrou)" userId="0c54211a-fdd0-48db-9439-148c878f923c" providerId="ADAL" clId="{B3918507-D423-4401-9C73-489D4DF24825}" dt="2025-04-22T14:48:19.745" v="96" actId="1076"/>
      <pc:docMkLst>
        <pc:docMk/>
      </pc:docMkLst>
      <pc:sldChg chg="modSp mod">
        <pc:chgData name="Zhang, C. (Congrou)" userId="0c54211a-fdd0-48db-9439-148c878f923c" providerId="ADAL" clId="{B3918507-D423-4401-9C73-489D4DF24825}" dt="2025-04-22T14:47:44.395" v="92" actId="1076"/>
        <pc:sldMkLst>
          <pc:docMk/>
          <pc:sldMk cId="2814622032" sldId="256"/>
        </pc:sldMkLst>
        <pc:spChg chg="mod">
          <ac:chgData name="Zhang, C. (Congrou)" userId="0c54211a-fdd0-48db-9439-148c878f923c" providerId="ADAL" clId="{B3918507-D423-4401-9C73-489D4DF24825}" dt="2025-04-22T14:47:44.395" v="92" actId="1076"/>
          <ac:spMkLst>
            <pc:docMk/>
            <pc:sldMk cId="2814622032" sldId="256"/>
            <ac:spMk id="4" creationId="{D002EC8F-12DE-491A-8F09-B641DDEDD3C6}"/>
          </ac:spMkLst>
        </pc:spChg>
        <pc:graphicFrameChg chg="modGraphic">
          <ac:chgData name="Zhang, C. (Congrou)" userId="0c54211a-fdd0-48db-9439-148c878f923c" providerId="ADAL" clId="{B3918507-D423-4401-9C73-489D4DF24825}" dt="2025-04-22T14:43:44.009" v="9" actId="2711"/>
          <ac:graphicFrameMkLst>
            <pc:docMk/>
            <pc:sldMk cId="2814622032" sldId="256"/>
            <ac:graphicFrameMk id="3" creationId="{60324925-4E36-479F-9ED6-FB96A1D37294}"/>
          </ac:graphicFrameMkLst>
        </pc:graphicFrameChg>
      </pc:sldChg>
      <pc:sldChg chg="modSp mod">
        <pc:chgData name="Zhang, C. (Congrou)" userId="0c54211a-fdd0-48db-9439-148c878f923c" providerId="ADAL" clId="{B3918507-D423-4401-9C73-489D4DF24825}" dt="2025-04-22T14:47:39.353" v="91" actId="1076"/>
        <pc:sldMkLst>
          <pc:docMk/>
          <pc:sldMk cId="3704335051" sldId="257"/>
        </pc:sldMkLst>
        <pc:spChg chg="mod">
          <ac:chgData name="Zhang, C. (Congrou)" userId="0c54211a-fdd0-48db-9439-148c878f923c" providerId="ADAL" clId="{B3918507-D423-4401-9C73-489D4DF24825}" dt="2025-04-22T14:47:39.353" v="91" actId="1076"/>
          <ac:spMkLst>
            <pc:docMk/>
            <pc:sldMk cId="3704335051" sldId="257"/>
            <ac:spMk id="6" creationId="{DE97A7E7-5920-4B8B-A2B8-E61F2209FD4F}"/>
          </ac:spMkLst>
        </pc:spChg>
        <pc:grpChg chg="mod">
          <ac:chgData name="Zhang, C. (Congrou)" userId="0c54211a-fdd0-48db-9439-148c878f923c" providerId="ADAL" clId="{B3918507-D423-4401-9C73-489D4DF24825}" dt="2025-04-22T14:47:35.433" v="90" actId="1035"/>
          <ac:grpSpMkLst>
            <pc:docMk/>
            <pc:sldMk cId="3704335051" sldId="257"/>
            <ac:grpSpMk id="2" creationId="{F28700C6-E050-46AC-AFCC-F754179A5C39}"/>
          </ac:grpSpMkLst>
        </pc:grpChg>
      </pc:sldChg>
      <pc:sldChg chg="modSp mod">
        <pc:chgData name="Zhang, C. (Congrou)" userId="0c54211a-fdd0-48db-9439-148c878f923c" providerId="ADAL" clId="{B3918507-D423-4401-9C73-489D4DF24825}" dt="2025-04-22T14:46:22.694" v="70" actId="1076"/>
        <pc:sldMkLst>
          <pc:docMk/>
          <pc:sldMk cId="1127109214" sldId="258"/>
        </pc:sldMkLst>
        <pc:spChg chg="mod">
          <ac:chgData name="Zhang, C. (Congrou)" userId="0c54211a-fdd0-48db-9439-148c878f923c" providerId="ADAL" clId="{B3918507-D423-4401-9C73-489D4DF24825}" dt="2025-04-22T14:46:19.684" v="69" actId="1076"/>
          <ac:spMkLst>
            <pc:docMk/>
            <pc:sldMk cId="1127109214" sldId="258"/>
            <ac:spMk id="3" creationId="{B44722D2-C230-4B04-B630-58801C7F5121}"/>
          </ac:spMkLst>
        </pc:spChg>
        <pc:picChg chg="mod">
          <ac:chgData name="Zhang, C. (Congrou)" userId="0c54211a-fdd0-48db-9439-148c878f923c" providerId="ADAL" clId="{B3918507-D423-4401-9C73-489D4DF24825}" dt="2025-04-22T14:46:22.694" v="70" actId="1076"/>
          <ac:picMkLst>
            <pc:docMk/>
            <pc:sldMk cId="1127109214" sldId="258"/>
            <ac:picMk id="2" creationId="{744C746F-64C6-4AE5-927F-7EC694ED535E}"/>
          </ac:picMkLst>
        </pc:picChg>
      </pc:sldChg>
      <pc:sldChg chg="addSp modSp mod">
        <pc:chgData name="Zhang, C. (Congrou)" userId="0c54211a-fdd0-48db-9439-148c878f923c" providerId="ADAL" clId="{B3918507-D423-4401-9C73-489D4DF24825}" dt="2025-04-22T14:48:03.792" v="94" actId="1076"/>
        <pc:sldMkLst>
          <pc:docMk/>
          <pc:sldMk cId="2777099009" sldId="268"/>
        </pc:sldMkLst>
        <pc:spChg chg="mod">
          <ac:chgData name="Zhang, C. (Congrou)" userId="0c54211a-fdd0-48db-9439-148c878f923c" providerId="ADAL" clId="{B3918507-D423-4401-9C73-489D4DF24825}" dt="2025-04-22T14:47:21.811" v="81" actId="164"/>
          <ac:spMkLst>
            <pc:docMk/>
            <pc:sldMk cId="2777099009" sldId="268"/>
            <ac:spMk id="10" creationId="{D2AE23E8-6800-4645-BECD-B37777FEE4E5}"/>
          </ac:spMkLst>
        </pc:spChg>
        <pc:spChg chg="mod">
          <ac:chgData name="Zhang, C. (Congrou)" userId="0c54211a-fdd0-48db-9439-148c878f923c" providerId="ADAL" clId="{B3918507-D423-4401-9C73-489D4DF24825}" dt="2025-04-22T14:48:03.792" v="94" actId="1076"/>
          <ac:spMkLst>
            <pc:docMk/>
            <pc:sldMk cId="2777099009" sldId="268"/>
            <ac:spMk id="11" creationId="{2F5BE1B1-BE0F-4EAC-8DA3-EE52764BF8F2}"/>
          </ac:spMkLst>
        </pc:spChg>
        <pc:spChg chg="mod">
          <ac:chgData name="Zhang, C. (Congrou)" userId="0c54211a-fdd0-48db-9439-148c878f923c" providerId="ADAL" clId="{B3918507-D423-4401-9C73-489D4DF24825}" dt="2025-04-22T14:47:21.811" v="81" actId="164"/>
          <ac:spMkLst>
            <pc:docMk/>
            <pc:sldMk cId="2777099009" sldId="268"/>
            <ac:spMk id="12" creationId="{272C2752-B9AF-45EB-8B7C-F894B30EDE98}"/>
          </ac:spMkLst>
        </pc:spChg>
        <pc:spChg chg="mod">
          <ac:chgData name="Zhang, C. (Congrou)" userId="0c54211a-fdd0-48db-9439-148c878f923c" providerId="ADAL" clId="{B3918507-D423-4401-9C73-489D4DF24825}" dt="2025-04-22T14:47:21.811" v="81" actId="164"/>
          <ac:spMkLst>
            <pc:docMk/>
            <pc:sldMk cId="2777099009" sldId="268"/>
            <ac:spMk id="13" creationId="{0D60B359-9B48-49A9-ABE0-F4B1C05798B5}"/>
          </ac:spMkLst>
        </pc:spChg>
        <pc:spChg chg="mod">
          <ac:chgData name="Zhang, C. (Congrou)" userId="0c54211a-fdd0-48db-9439-148c878f923c" providerId="ADAL" clId="{B3918507-D423-4401-9C73-489D4DF24825}" dt="2025-04-22T14:47:21.811" v="81" actId="164"/>
          <ac:spMkLst>
            <pc:docMk/>
            <pc:sldMk cId="2777099009" sldId="268"/>
            <ac:spMk id="14" creationId="{78702C07-BD05-4688-9EEC-B2D91DF8B635}"/>
          </ac:spMkLst>
        </pc:spChg>
        <pc:grpChg chg="add mod">
          <ac:chgData name="Zhang, C. (Congrou)" userId="0c54211a-fdd0-48db-9439-148c878f923c" providerId="ADAL" clId="{B3918507-D423-4401-9C73-489D4DF24825}" dt="2025-04-22T14:47:21.811" v="81" actId="164"/>
          <ac:grpSpMkLst>
            <pc:docMk/>
            <pc:sldMk cId="2777099009" sldId="268"/>
            <ac:grpSpMk id="2" creationId="{80027EEF-F0D4-8438-BC02-09CCB3C65A8F}"/>
          </ac:grpSpMkLst>
        </pc:grpChg>
        <pc:grpChg chg="add mod">
          <ac:chgData name="Zhang, C. (Congrou)" userId="0c54211a-fdd0-48db-9439-148c878f923c" providerId="ADAL" clId="{B3918507-D423-4401-9C73-489D4DF24825}" dt="2025-04-22T14:47:23.955" v="82" actId="1076"/>
          <ac:grpSpMkLst>
            <pc:docMk/>
            <pc:sldMk cId="2777099009" sldId="268"/>
            <ac:grpSpMk id="4" creationId="{C076EA46-7B94-5D5D-53A0-187979D68C4B}"/>
          </ac:grpSpMkLst>
        </pc:grpChg>
        <pc:picChg chg="mod">
          <ac:chgData name="Zhang, C. (Congrou)" userId="0c54211a-fdd0-48db-9439-148c878f923c" providerId="ADAL" clId="{B3918507-D423-4401-9C73-489D4DF24825}" dt="2025-04-22T14:47:04.883" v="78" actId="164"/>
          <ac:picMkLst>
            <pc:docMk/>
            <pc:sldMk cId="2777099009" sldId="268"/>
            <ac:picMk id="3" creationId="{AD49F894-3B94-4149-A7E4-AB82D0A8F3E7}"/>
          </ac:picMkLst>
        </pc:picChg>
        <pc:picChg chg="mod">
          <ac:chgData name="Zhang, C. (Congrou)" userId="0c54211a-fdd0-48db-9439-148c878f923c" providerId="ADAL" clId="{B3918507-D423-4401-9C73-489D4DF24825}" dt="2025-04-22T14:47:04.883" v="78" actId="164"/>
          <ac:picMkLst>
            <pc:docMk/>
            <pc:sldMk cId="2777099009" sldId="268"/>
            <ac:picMk id="5" creationId="{6E36A585-2D70-4AE2-BAC2-66E14D4191EF}"/>
          </ac:picMkLst>
        </pc:picChg>
        <pc:picChg chg="mod">
          <ac:chgData name="Zhang, C. (Congrou)" userId="0c54211a-fdd0-48db-9439-148c878f923c" providerId="ADAL" clId="{B3918507-D423-4401-9C73-489D4DF24825}" dt="2025-04-22T14:47:04.883" v="78" actId="164"/>
          <ac:picMkLst>
            <pc:docMk/>
            <pc:sldMk cId="2777099009" sldId="268"/>
            <ac:picMk id="7" creationId="{8127536B-334C-433F-B36E-2BB3EA3D837E}"/>
          </ac:picMkLst>
        </pc:picChg>
        <pc:picChg chg="mod">
          <ac:chgData name="Zhang, C. (Congrou)" userId="0c54211a-fdd0-48db-9439-148c878f923c" providerId="ADAL" clId="{B3918507-D423-4401-9C73-489D4DF24825}" dt="2025-04-22T14:47:04.883" v="78" actId="164"/>
          <ac:picMkLst>
            <pc:docMk/>
            <pc:sldMk cId="2777099009" sldId="268"/>
            <ac:picMk id="9" creationId="{E1590D80-FD40-4351-A77C-90D9EBE215F4}"/>
          </ac:picMkLst>
        </pc:picChg>
      </pc:sldChg>
      <pc:sldChg chg="addSp modSp mod">
        <pc:chgData name="Zhang, C. (Congrou)" userId="0c54211a-fdd0-48db-9439-148c878f923c" providerId="ADAL" clId="{B3918507-D423-4401-9C73-489D4DF24825}" dt="2025-04-22T14:48:16.540" v="95" actId="1076"/>
        <pc:sldMkLst>
          <pc:docMk/>
          <pc:sldMk cId="1990302366" sldId="269"/>
        </pc:sldMkLst>
        <pc:spChg chg="mod">
          <ac:chgData name="Zhang, C. (Congrou)" userId="0c54211a-fdd0-48db-9439-148c878f923c" providerId="ADAL" clId="{B3918507-D423-4401-9C73-489D4DF24825}" dt="2025-04-22T14:46:50.475" v="75" actId="164"/>
          <ac:spMkLst>
            <pc:docMk/>
            <pc:sldMk cId="1990302366" sldId="269"/>
            <ac:spMk id="10" creationId="{88980111-605C-4A10-9384-DE84F054E341}"/>
          </ac:spMkLst>
        </pc:spChg>
        <pc:spChg chg="mod">
          <ac:chgData name="Zhang, C. (Congrou)" userId="0c54211a-fdd0-48db-9439-148c878f923c" providerId="ADAL" clId="{B3918507-D423-4401-9C73-489D4DF24825}" dt="2025-04-22T14:46:50.475" v="75" actId="164"/>
          <ac:spMkLst>
            <pc:docMk/>
            <pc:sldMk cId="1990302366" sldId="269"/>
            <ac:spMk id="11" creationId="{D99A4976-C2A9-4027-BF05-8E720868A20C}"/>
          </ac:spMkLst>
        </pc:spChg>
        <pc:spChg chg="mod">
          <ac:chgData name="Zhang, C. (Congrou)" userId="0c54211a-fdd0-48db-9439-148c878f923c" providerId="ADAL" clId="{B3918507-D423-4401-9C73-489D4DF24825}" dt="2025-04-22T14:46:50.475" v="75" actId="164"/>
          <ac:spMkLst>
            <pc:docMk/>
            <pc:sldMk cId="1990302366" sldId="269"/>
            <ac:spMk id="12" creationId="{C1453784-C2D8-4016-AB03-8C248408383C}"/>
          </ac:spMkLst>
        </pc:spChg>
        <pc:spChg chg="mod">
          <ac:chgData name="Zhang, C. (Congrou)" userId="0c54211a-fdd0-48db-9439-148c878f923c" providerId="ADAL" clId="{B3918507-D423-4401-9C73-489D4DF24825}" dt="2025-04-22T14:46:50.475" v="75" actId="164"/>
          <ac:spMkLst>
            <pc:docMk/>
            <pc:sldMk cId="1990302366" sldId="269"/>
            <ac:spMk id="13" creationId="{2754EE69-EC9B-4CC1-BDAD-71B8558871C6}"/>
          </ac:spMkLst>
        </pc:spChg>
        <pc:spChg chg="mod">
          <ac:chgData name="Zhang, C. (Congrou)" userId="0c54211a-fdd0-48db-9439-148c878f923c" providerId="ADAL" clId="{B3918507-D423-4401-9C73-489D4DF24825}" dt="2025-04-22T14:46:55.789" v="77" actId="1076"/>
          <ac:spMkLst>
            <pc:docMk/>
            <pc:sldMk cId="1990302366" sldId="269"/>
            <ac:spMk id="14" creationId="{73AD24E3-52EE-47E0-A8F8-DA774397451D}"/>
          </ac:spMkLst>
        </pc:spChg>
        <pc:grpChg chg="add mod">
          <ac:chgData name="Zhang, C. (Congrou)" userId="0c54211a-fdd0-48db-9439-148c878f923c" providerId="ADAL" clId="{B3918507-D423-4401-9C73-489D4DF24825}" dt="2025-04-22T14:48:16.540" v="95" actId="1076"/>
          <ac:grpSpMkLst>
            <pc:docMk/>
            <pc:sldMk cId="1990302366" sldId="269"/>
            <ac:grpSpMk id="2" creationId="{CA5E6063-8579-093D-2C0E-C98F3E67F164}"/>
          </ac:grpSpMkLst>
        </pc:grpChg>
        <pc:picChg chg="mod">
          <ac:chgData name="Zhang, C. (Congrou)" userId="0c54211a-fdd0-48db-9439-148c878f923c" providerId="ADAL" clId="{B3918507-D423-4401-9C73-489D4DF24825}" dt="2025-04-22T14:46:50.475" v="75" actId="164"/>
          <ac:picMkLst>
            <pc:docMk/>
            <pc:sldMk cId="1990302366" sldId="269"/>
            <ac:picMk id="3" creationId="{8C96C9E9-BB6E-4A9D-A48E-27E7F29D546E}"/>
          </ac:picMkLst>
        </pc:picChg>
        <pc:picChg chg="mod">
          <ac:chgData name="Zhang, C. (Congrou)" userId="0c54211a-fdd0-48db-9439-148c878f923c" providerId="ADAL" clId="{B3918507-D423-4401-9C73-489D4DF24825}" dt="2025-04-22T14:46:50.475" v="75" actId="164"/>
          <ac:picMkLst>
            <pc:docMk/>
            <pc:sldMk cId="1990302366" sldId="269"/>
            <ac:picMk id="5" creationId="{B5CD703D-4458-4BBE-8447-62B85A9FEDD0}"/>
          </ac:picMkLst>
        </pc:picChg>
        <pc:picChg chg="mod">
          <ac:chgData name="Zhang, C. (Congrou)" userId="0c54211a-fdd0-48db-9439-148c878f923c" providerId="ADAL" clId="{B3918507-D423-4401-9C73-489D4DF24825}" dt="2025-04-22T14:46:50.475" v="75" actId="164"/>
          <ac:picMkLst>
            <pc:docMk/>
            <pc:sldMk cId="1990302366" sldId="269"/>
            <ac:picMk id="7" creationId="{451D56DC-3F1D-4737-AEA7-44A6C31DEAB4}"/>
          </ac:picMkLst>
        </pc:picChg>
        <pc:picChg chg="mod">
          <ac:chgData name="Zhang, C. (Congrou)" userId="0c54211a-fdd0-48db-9439-148c878f923c" providerId="ADAL" clId="{B3918507-D423-4401-9C73-489D4DF24825}" dt="2025-04-22T14:46:50.475" v="75" actId="164"/>
          <ac:picMkLst>
            <pc:docMk/>
            <pc:sldMk cId="1990302366" sldId="269"/>
            <ac:picMk id="9" creationId="{68B2E3B1-6A2F-4342-90A6-5DB9BE253CCB}"/>
          </ac:picMkLst>
        </pc:picChg>
      </pc:sldChg>
      <pc:sldChg chg="modSp mod">
        <pc:chgData name="Zhang, C. (Congrou)" userId="0c54211a-fdd0-48db-9439-148c878f923c" providerId="ADAL" clId="{B3918507-D423-4401-9C73-489D4DF24825}" dt="2025-04-22T14:48:19.745" v="96" actId="1076"/>
        <pc:sldMkLst>
          <pc:docMk/>
          <pc:sldMk cId="3291071728" sldId="270"/>
        </pc:sldMkLst>
        <pc:spChg chg="mod">
          <ac:chgData name="Zhang, C. (Congrou)" userId="0c54211a-fdd0-48db-9439-148c878f923c" providerId="ADAL" clId="{B3918507-D423-4401-9C73-489D4DF24825}" dt="2025-04-22T14:46:34.949" v="72" actId="1076"/>
          <ac:spMkLst>
            <pc:docMk/>
            <pc:sldMk cId="3291071728" sldId="270"/>
            <ac:spMk id="14" creationId="{2F5BE1B1-BE0F-4EAC-8DA3-EE52764BF8F2}"/>
          </ac:spMkLst>
        </pc:spChg>
        <pc:grpChg chg="mod">
          <ac:chgData name="Zhang, C. (Congrou)" userId="0c54211a-fdd0-48db-9439-148c878f923c" providerId="ADAL" clId="{B3918507-D423-4401-9C73-489D4DF24825}" dt="2025-04-22T14:48:19.745" v="96" actId="1076"/>
          <ac:grpSpMkLst>
            <pc:docMk/>
            <pc:sldMk cId="3291071728" sldId="270"/>
            <ac:grpSpMk id="2" creationId="{0931DB68-FEE1-4958-B56D-D20EF416F687}"/>
          </ac:grpSpMkLst>
        </pc:grpChg>
      </pc:sldChg>
    </pc:docChg>
  </pc:docChgLst>
  <pc:docChgLst>
    <pc:chgData name="Zhang, C. (Congrou)" userId="0c54211a-fdd0-48db-9439-148c878f923c" providerId="ADAL" clId="{57D47819-5332-44B3-938C-533F60AFCE51}"/>
    <pc:docChg chg="modSld">
      <pc:chgData name="Zhang, C. (Congrou)" userId="0c54211a-fdd0-48db-9439-148c878f923c" providerId="ADAL" clId="{57D47819-5332-44B3-938C-533F60AFCE51}" dt="2025-01-21T14:44:58.515" v="5" actId="1076"/>
      <pc:docMkLst>
        <pc:docMk/>
      </pc:docMkLst>
      <pc:sldChg chg="modSp">
        <pc:chgData name="Zhang, C. (Congrou)" userId="0c54211a-fdd0-48db-9439-148c878f923c" providerId="ADAL" clId="{57D47819-5332-44B3-938C-533F60AFCE51}" dt="2025-01-21T14:44:58.515" v="5" actId="1076"/>
        <pc:sldMkLst>
          <pc:docMk/>
          <pc:sldMk cId="3613632641" sldId="271"/>
        </pc:sldMkLst>
      </pc:sldChg>
    </pc:docChg>
  </pc:docChgLst>
  <pc:docChgLst>
    <pc:chgData name="Zhang, C. (Congrou)" userId="0c54211a-fdd0-48db-9439-148c878f923c" providerId="ADAL" clId="{909357BA-7E34-48C3-B8C8-A7CD68E5DE4B}"/>
    <pc:docChg chg="addSld modSld">
      <pc:chgData name="Zhang, C. (Congrou)" userId="0c54211a-fdd0-48db-9439-148c878f923c" providerId="ADAL" clId="{909357BA-7E34-48C3-B8C8-A7CD68E5DE4B}" dt="2024-11-14T13:22:32.461" v="18" actId="1076"/>
      <pc:docMkLst>
        <pc:docMk/>
      </pc:docMkLst>
      <pc:sldChg chg="addSp modSp new">
        <pc:chgData name="Zhang, C. (Congrou)" userId="0c54211a-fdd0-48db-9439-148c878f923c" providerId="ADAL" clId="{909357BA-7E34-48C3-B8C8-A7CD68E5DE4B}" dt="2024-11-14T13:22:32.461" v="18" actId="1076"/>
        <pc:sldMkLst>
          <pc:docMk/>
          <pc:sldMk cId="3613632641" sldId="271"/>
        </pc:sldMkLst>
      </pc:sldChg>
    </pc:docChg>
  </pc:docChgLst>
  <pc:docChgLst>
    <pc:chgData name="Congrou Zhang" userId="0c54211a-fdd0-48db-9439-148c878f923c" providerId="ADAL" clId="{D5F255C1-40AD-4F77-BA23-88A831783CCE}"/>
    <pc:docChg chg="undo custSel addSld delSld modSld">
      <pc:chgData name="Congrou Zhang" userId="0c54211a-fdd0-48db-9439-148c878f923c" providerId="ADAL" clId="{D5F255C1-40AD-4F77-BA23-88A831783CCE}" dt="2024-08-21T09:49:03.637" v="286" actId="2696"/>
      <pc:docMkLst>
        <pc:docMk/>
      </pc:docMkLst>
      <pc:sldChg chg="addSp delSp modSp add">
        <pc:chgData name="Congrou Zhang" userId="0c54211a-fdd0-48db-9439-148c878f923c" providerId="ADAL" clId="{D5F255C1-40AD-4F77-BA23-88A831783CCE}" dt="2024-08-20T20:13:49.160" v="128" actId="1076"/>
        <pc:sldMkLst>
          <pc:docMk/>
          <pc:sldMk cId="2814622032" sldId="256"/>
        </pc:sldMkLst>
      </pc:sldChg>
      <pc:sldChg chg="addSp modSp add">
        <pc:chgData name="Congrou Zhang" userId="0c54211a-fdd0-48db-9439-148c878f923c" providerId="ADAL" clId="{D5F255C1-40AD-4F77-BA23-88A831783CCE}" dt="2024-08-20T20:13:37.666" v="125" actId="1076"/>
        <pc:sldMkLst>
          <pc:docMk/>
          <pc:sldMk cId="3704335051" sldId="257"/>
        </pc:sldMkLst>
      </pc:sldChg>
      <pc:sldChg chg="addSp modSp add">
        <pc:chgData name="Congrou Zhang" userId="0c54211a-fdd0-48db-9439-148c878f923c" providerId="ADAL" clId="{D5F255C1-40AD-4F77-BA23-88A831783CCE}" dt="2024-08-20T20:25:53.212" v="285" actId="20577"/>
        <pc:sldMkLst>
          <pc:docMk/>
          <pc:sldMk cId="1127109214" sldId="258"/>
        </pc:sldMkLst>
      </pc:sldChg>
      <pc:sldChg chg="add del">
        <pc:chgData name="Congrou Zhang" userId="0c54211a-fdd0-48db-9439-148c878f923c" providerId="ADAL" clId="{D5F255C1-40AD-4F77-BA23-88A831783CCE}" dt="2024-08-21T09:49:03.637" v="286" actId="2696"/>
        <pc:sldMkLst>
          <pc:docMk/>
          <pc:sldMk cId="1272102043" sldId="259"/>
        </pc:sldMkLst>
      </pc:sldChg>
      <pc:sldChg chg="addSp modSp add">
        <pc:chgData name="Congrou Zhang" userId="0c54211a-fdd0-48db-9439-148c878f923c" providerId="ADAL" clId="{D5F255C1-40AD-4F77-BA23-88A831783CCE}" dt="2024-08-20T20:21:42.717" v="240" actId="20577"/>
        <pc:sldMkLst>
          <pc:docMk/>
          <pc:sldMk cId="2777099009" sldId="268"/>
        </pc:sldMkLst>
      </pc:sldChg>
      <pc:sldChg chg="addSp modSp add">
        <pc:chgData name="Congrou Zhang" userId="0c54211a-fdd0-48db-9439-148c878f923c" providerId="ADAL" clId="{D5F255C1-40AD-4F77-BA23-88A831783CCE}" dt="2024-08-20T20:22:34.802" v="249" actId="1076"/>
        <pc:sldMkLst>
          <pc:docMk/>
          <pc:sldMk cId="1990302366" sldId="269"/>
        </pc:sldMkLst>
      </pc:sldChg>
      <pc:sldChg chg="addSp modSp add">
        <pc:chgData name="Congrou Zhang" userId="0c54211a-fdd0-48db-9439-148c878f923c" providerId="ADAL" clId="{D5F255C1-40AD-4F77-BA23-88A831783CCE}" dt="2024-08-20T20:23:27.412" v="269" actId="20577"/>
        <pc:sldMkLst>
          <pc:docMk/>
          <pc:sldMk cId="3291071728" sldId="270"/>
        </pc:sldMkLst>
      </pc:sldChg>
    </pc:docChg>
  </pc:docChgLst>
  <pc:docChgLst>
    <pc:chgData name="Zhang, C. (Congrou)" userId="0c54211a-fdd0-48db-9439-148c878f923c" providerId="ADAL" clId="{0C733AFD-468E-4417-AFD2-8125ABE062E2}"/>
    <pc:docChg chg="modSld">
      <pc:chgData name="Zhang, C. (Congrou)" userId="0c54211a-fdd0-48db-9439-148c878f923c" providerId="ADAL" clId="{0C733AFD-468E-4417-AFD2-8125ABE062E2}" dt="2025-07-18T09:10:14.996" v="87" actId="20577"/>
      <pc:docMkLst>
        <pc:docMk/>
      </pc:docMkLst>
      <pc:sldChg chg="modSp mod">
        <pc:chgData name="Zhang, C. (Congrou)" userId="0c54211a-fdd0-48db-9439-148c878f923c" providerId="ADAL" clId="{0C733AFD-468E-4417-AFD2-8125ABE062E2}" dt="2025-07-18T09:10:14.996" v="87" actId="20577"/>
        <pc:sldMkLst>
          <pc:docMk/>
          <pc:sldMk cId="1127109214" sldId="258"/>
        </pc:sldMkLst>
        <pc:spChg chg="mod">
          <ac:chgData name="Zhang, C. (Congrou)" userId="0c54211a-fdd0-48db-9439-148c878f923c" providerId="ADAL" clId="{0C733AFD-468E-4417-AFD2-8125ABE062E2}" dt="2025-07-18T09:10:14.996" v="87" actId="20577"/>
          <ac:spMkLst>
            <pc:docMk/>
            <pc:sldMk cId="1127109214" sldId="258"/>
            <ac:spMk id="3" creationId="{B44722D2-C230-4B04-B630-58801C7F5121}"/>
          </ac:spMkLst>
        </pc:spChg>
      </pc:sldChg>
    </pc:docChg>
  </pc:docChgLst>
  <pc:docChgLst>
    <pc:chgData name="Zhang, C. (Congrou)" userId="0c54211a-fdd0-48db-9439-148c878f923c" providerId="ADAL" clId="{F69EF5C6-2690-48A8-9056-63F9BFA7C8FC}"/>
    <pc:docChg chg="undo custSel delSld modSld">
      <pc:chgData name="Zhang, C. (Congrou)" userId="0c54211a-fdd0-48db-9439-148c878f923c" providerId="ADAL" clId="{F69EF5C6-2690-48A8-9056-63F9BFA7C8FC}" dt="2025-03-05T11:09:40.535" v="7" actId="20577"/>
      <pc:docMkLst>
        <pc:docMk/>
      </pc:docMkLst>
      <pc:sldChg chg="modSp mod">
        <pc:chgData name="Zhang, C. (Congrou)" userId="0c54211a-fdd0-48db-9439-148c878f923c" providerId="ADAL" clId="{F69EF5C6-2690-48A8-9056-63F9BFA7C8FC}" dt="2025-03-05T11:08:23.583" v="3" actId="57"/>
        <pc:sldMkLst>
          <pc:docMk/>
          <pc:sldMk cId="2777099009" sldId="268"/>
        </pc:sldMkLst>
      </pc:sldChg>
      <pc:sldChg chg="modSp mod">
        <pc:chgData name="Zhang, C. (Congrou)" userId="0c54211a-fdd0-48db-9439-148c878f923c" providerId="ADAL" clId="{F69EF5C6-2690-48A8-9056-63F9BFA7C8FC}" dt="2025-03-05T11:09:40.535" v="7" actId="20577"/>
        <pc:sldMkLst>
          <pc:docMk/>
          <pc:sldMk cId="1990302366" sldId="269"/>
        </pc:sldMkLst>
      </pc:sldChg>
      <pc:sldChg chg="modSp mod">
        <pc:chgData name="Zhang, C. (Congrou)" userId="0c54211a-fdd0-48db-9439-148c878f923c" providerId="ADAL" clId="{F69EF5C6-2690-48A8-9056-63F9BFA7C8FC}" dt="2025-03-05T11:08:41.758" v="5" actId="57"/>
        <pc:sldMkLst>
          <pc:docMk/>
          <pc:sldMk cId="3291071728" sldId="270"/>
        </pc:sldMkLst>
      </pc:sldChg>
      <pc:sldChg chg="del">
        <pc:chgData name="Zhang, C. (Congrou)" userId="0c54211a-fdd0-48db-9439-148c878f923c" providerId="ADAL" clId="{F69EF5C6-2690-48A8-9056-63F9BFA7C8FC}" dt="2025-03-05T10:55:32.870" v="0" actId="47"/>
        <pc:sldMkLst>
          <pc:docMk/>
          <pc:sldMk cId="3613632641" sldId="271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39C5D0-F8DE-43D2-AEFD-A203515DAA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9276C86-D9D4-4CF3-9900-C34292F5B7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B074D3-79F6-4B81-91B1-7C0F29D42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924342-7C1F-45D6-9188-612E08F9A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F90F40-CB61-41A4-A02A-0B9C7BBD6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069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D50EE-F280-4581-A32D-CF87435423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32F6F4-0B8D-4880-A9AD-F64FEB1239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FC9C96-E25A-41A2-BD3E-94287D9E6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120D80-510E-4A46-8E3B-432DD88789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85E2F2-5D67-44B8-A480-5D3209358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938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827F60-BFFF-4EBB-B5DE-290CB7C448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8B6A18-7466-4C51-A442-F57810E97F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1BB560-C4A5-41D6-B015-520E7B49B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064E6B-9067-4867-81B1-3B3B10684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973AE8-CF13-4F29-8F59-FDD666AC5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36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E801A-D54F-4281-A9EA-CDE07E74AF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630AAF-50FC-4FCB-84CD-653729EEE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25E87C-6743-455E-9AEA-FBC1CCA0C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C84700-21FF-4E5C-B97D-AD5455AEF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E94B5-058E-4A6E-8638-4398788BA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787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AF0654-FB96-4D8F-9BF3-5A17C19B57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A70F12-7A9E-4C3C-A70A-0924E42D46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E0ED98-3ADF-4A95-9D44-FA4C6B973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54DF15-10D9-40C4-8962-736C58947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8FA2B1-E8FC-4ED0-8718-E82ED364F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79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8C116C-78BC-4151-9057-DD17C04121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FF99BA-E963-426D-9F47-9CFB826DA2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A24943-BD69-408C-9FBA-D132C244E3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2068DE-C97C-4D87-AA1A-13B71322FC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786C65-0D43-44CC-B5F9-EF8FEA0AD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8FB0D1-4B50-4F0A-AC16-0265797CF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548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B351E9-B0E9-4BFE-B767-CAFB414692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F1B1CF-9E54-407A-9B1E-8EA5A029B3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639576-DCC1-4FFB-B3D5-895B925A74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71A819-18DA-4B4E-ACD2-030465ABB0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33AF88-B55E-4224-9FD9-D35C6A8D98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EA226A-A9A4-4DE0-A64F-ED3B7EB89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4AF1B0-3B17-4226-AFF6-D8D7E91B5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E738D70-C708-4F5B-AE5D-CEBC5027C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839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6105D-EBE0-41C3-B0C6-0BDEBDF07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DFDDB9-2AFC-494D-933B-5E4F4C40F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D6673D-8F44-44D4-9666-FB4455621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3EE6C6-FD18-4AC7-99CB-C87EB842B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399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24961F-FAB9-4A7A-807A-282838098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C04411-6488-4F8A-86F5-554821E2D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04C060-125B-4841-B054-864C84B57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246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3B296-04EF-44F2-9432-E15FDAEDF0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5C0F36-DF55-45B6-973F-E32FEF386E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26E9C3-A050-49DF-9B35-DE7C551FA6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6FD3A0-F7F0-4A14-8E83-38B557735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81EAC1-6C3F-47E6-890A-C81BC2F9F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E47DE0-D0AF-44A8-BC54-D795BB697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887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C72A7-8ED9-455B-A640-00A33AF7CB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8CF36D-0FE1-4D4B-B810-E44C647C78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DB0968-4C52-4B01-A714-48D7FD10C6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ADBB24-8375-4B9A-B9CF-98E953D7F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C63FB1-DBBA-4EB9-AA87-7E42750F3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C940CC-FB97-4837-A10F-CAA4A90FA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890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95C521F-D33B-441B-B4AD-0318EA0A6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E03E4A-9972-4C64-BB29-6CC954E4E0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CD7F07-2807-4A5E-95AD-6098A7D3DC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DB2DC7-D85F-42B8-935F-511372A6892E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939382-3053-4C81-A064-0ECC716916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009FC-C1E0-470D-9EA2-67207D6944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D9E592-B66A-4A1F-B5FB-1C5C2FF288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049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0324925-4E36-479F-9ED6-FB96A1D372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8251329"/>
              </p:ext>
            </p:extLst>
          </p:nvPr>
        </p:nvGraphicFramePr>
        <p:xfrm>
          <a:off x="1749197" y="1520944"/>
          <a:ext cx="8128000" cy="296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0">
                  <a:extLst>
                    <a:ext uri="{9D8B030D-6E8A-4147-A177-3AD203B41FA5}">
                      <a16:colId xmlns:a16="http://schemas.microsoft.com/office/drawing/2014/main" val="3290454694"/>
                    </a:ext>
                  </a:extLst>
                </a:gridCol>
                <a:gridCol w="4064000">
                  <a:extLst>
                    <a:ext uri="{9D8B030D-6E8A-4147-A177-3AD203B41FA5}">
                      <a16:colId xmlns:a16="http://schemas.microsoft.com/office/drawing/2014/main" val="2483707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l vari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92943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ray volta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0 v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91787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pillary temperatu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0 °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00641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lens RF leve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0101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 r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7-397 m/z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63698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 AGC targ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0E+0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22639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 maximum injection ti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</a:t>
                      </a:r>
                      <a:r>
                        <a:rPr lang="en-US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75121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 resolu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000 FWH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4951634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002EC8F-12DE-491A-8F09-B641DDEDD3C6}"/>
              </a:ext>
            </a:extLst>
          </p:cNvPr>
          <p:cNvSpPr txBox="1"/>
          <p:nvPr/>
        </p:nvSpPr>
        <p:spPr>
          <a:xfrm>
            <a:off x="3886872" y="4739124"/>
            <a:ext cx="5024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.S-1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ometry parameters. </a:t>
            </a:r>
          </a:p>
        </p:txBody>
      </p:sp>
    </p:spTree>
    <p:extLst>
      <p:ext uri="{BB962C8B-B14F-4D97-AF65-F5344CB8AC3E}">
        <p14:creationId xmlns:p14="http://schemas.microsoft.com/office/powerpoint/2010/main" val="2814622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28700C6-E050-46AC-AFCC-F754179A5C39}"/>
              </a:ext>
            </a:extLst>
          </p:cNvPr>
          <p:cNvGrpSpPr/>
          <p:nvPr/>
        </p:nvGrpSpPr>
        <p:grpSpPr>
          <a:xfrm>
            <a:off x="3424177" y="211371"/>
            <a:ext cx="4616888" cy="5981196"/>
            <a:chOff x="3094238" y="197658"/>
            <a:chExt cx="4926330" cy="797998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B270CDC-7FEA-47BA-8402-B16F6BF4AD83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0908" y="197658"/>
              <a:ext cx="4875530" cy="2710815"/>
            </a:xfrm>
            <a:prstGeom prst="rect">
              <a:avLst/>
            </a:prstGeom>
            <a:noFill/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5D248AE-4E06-4984-99B4-2DC86F9E3D32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0908" y="2735691"/>
              <a:ext cx="4872990" cy="2706370"/>
            </a:xfrm>
            <a:prstGeom prst="rect">
              <a:avLst/>
            </a:prstGeom>
            <a:noFill/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A4AD111-6143-4ED5-BDA9-B2E74C3B477B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4238" y="5442061"/>
              <a:ext cx="4926330" cy="2735580"/>
            </a:xfrm>
            <a:prstGeom prst="rect">
              <a:avLst/>
            </a:prstGeom>
            <a:noFill/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DE97A7E7-5920-4B8B-A2B8-E61F2209FD4F}"/>
              </a:ext>
            </a:extLst>
          </p:cNvPr>
          <p:cNvSpPr txBox="1"/>
          <p:nvPr/>
        </p:nvSpPr>
        <p:spPr>
          <a:xfrm>
            <a:off x="2100606" y="6211669"/>
            <a:ext cx="93262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-1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(a) tamoxifen, (b) 4-OH-tamoxifen and (c) N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methyltamoixfe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different group at single cell level. </a:t>
            </a:r>
          </a:p>
        </p:txBody>
      </p:sp>
    </p:spTree>
    <p:extLst>
      <p:ext uri="{BB962C8B-B14F-4D97-AF65-F5344CB8AC3E}">
        <p14:creationId xmlns:p14="http://schemas.microsoft.com/office/powerpoint/2010/main" val="3704335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076EA46-7B94-5D5D-53A0-187979D68C4B}"/>
              </a:ext>
            </a:extLst>
          </p:cNvPr>
          <p:cNvGrpSpPr/>
          <p:nvPr/>
        </p:nvGrpSpPr>
        <p:grpSpPr>
          <a:xfrm>
            <a:off x="2201210" y="273424"/>
            <a:ext cx="7789579" cy="6047244"/>
            <a:chOff x="1520678" y="339401"/>
            <a:chExt cx="7789579" cy="6047244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80027EEF-F0D4-8438-BC02-09CCB3C65A8F}"/>
                </a:ext>
              </a:extLst>
            </p:cNvPr>
            <p:cNvGrpSpPr/>
            <p:nvPr/>
          </p:nvGrpSpPr>
          <p:grpSpPr>
            <a:xfrm>
              <a:off x="1635377" y="339401"/>
              <a:ext cx="7674880" cy="6047244"/>
              <a:chOff x="1635377" y="339401"/>
              <a:chExt cx="7674880" cy="6047244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AD49F894-3B94-4149-A7E4-AB82D0A8F3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35377" y="3363023"/>
                <a:ext cx="3837440" cy="3023622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6E36A585-2D70-4AE2-BAC2-66E14D4191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37278" y="405378"/>
                <a:ext cx="3837440" cy="3023622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8127536B-334C-433F-B36E-2BB3EA3D83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72817" y="339401"/>
                <a:ext cx="3837440" cy="3023622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E1590D80-FD40-4351-A77C-90D9EBE215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71867" y="3363023"/>
                <a:ext cx="3837440" cy="3023622"/>
              </a:xfrm>
              <a:prstGeom prst="rect">
                <a:avLst/>
              </a:prstGeom>
            </p:spPr>
          </p:pic>
        </p:grp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D2AE23E8-6800-4645-BECD-B37777FEE4E5}"/>
                </a:ext>
              </a:extLst>
            </p:cNvPr>
            <p:cNvSpPr/>
            <p:nvPr/>
          </p:nvSpPr>
          <p:spPr>
            <a:xfrm>
              <a:off x="1528725" y="405378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A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72C2752-B9AF-45EB-8B7C-F894B30EDE98}"/>
                </a:ext>
              </a:extLst>
            </p:cNvPr>
            <p:cNvSpPr/>
            <p:nvPr/>
          </p:nvSpPr>
          <p:spPr>
            <a:xfrm>
              <a:off x="5221812" y="3429000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D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0D60B359-9B48-49A9-ABE0-F4B1C05798B5}"/>
                </a:ext>
              </a:extLst>
            </p:cNvPr>
            <p:cNvSpPr/>
            <p:nvPr/>
          </p:nvSpPr>
          <p:spPr>
            <a:xfrm>
              <a:off x="1520678" y="3429000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C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78702C07-BD05-4688-9EEC-B2D91DF8B635}"/>
                </a:ext>
              </a:extLst>
            </p:cNvPr>
            <p:cNvSpPr/>
            <p:nvPr/>
          </p:nvSpPr>
          <p:spPr>
            <a:xfrm>
              <a:off x="5221812" y="405377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B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2F5BE1B1-BE0F-4EAC-8DA3-EE52764BF8F2}"/>
              </a:ext>
            </a:extLst>
          </p:cNvPr>
          <p:cNvSpPr txBox="1"/>
          <p:nvPr/>
        </p:nvSpPr>
        <p:spPr>
          <a:xfrm>
            <a:off x="2357633" y="6333933"/>
            <a:ext cx="9326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-2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Raman shift 1001, 1173, 1589, 1603 cm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amoxifen</a:t>
            </a:r>
          </a:p>
        </p:txBody>
      </p:sp>
    </p:spTree>
    <p:extLst>
      <p:ext uri="{BB962C8B-B14F-4D97-AF65-F5344CB8AC3E}">
        <p14:creationId xmlns:p14="http://schemas.microsoft.com/office/powerpoint/2010/main" val="27770990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A5E6063-8579-093D-2C0E-C98F3E67F164}"/>
              </a:ext>
            </a:extLst>
          </p:cNvPr>
          <p:cNvGrpSpPr/>
          <p:nvPr/>
        </p:nvGrpSpPr>
        <p:grpSpPr>
          <a:xfrm>
            <a:off x="2225662" y="233337"/>
            <a:ext cx="7740676" cy="6124703"/>
            <a:chOff x="1664118" y="405377"/>
            <a:chExt cx="7740676" cy="612470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C96C9E9-BB6E-4A9D-A48E-27E7F29D546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7354" y="3429000"/>
              <a:ext cx="3837440" cy="302362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5CD703D-4458-4BBE-8447-62B85A9FED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29914" y="482836"/>
              <a:ext cx="3837440" cy="302362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51D56DC-3F1D-4737-AEA7-44A6C31DEAB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7354" y="405378"/>
              <a:ext cx="3837440" cy="302362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8B2E3B1-6A2F-4342-90A6-5DB9BE253CC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29914" y="3506458"/>
              <a:ext cx="3837440" cy="3023622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8980111-605C-4A10-9384-DE84F054E341}"/>
                </a:ext>
              </a:extLst>
            </p:cNvPr>
            <p:cNvSpPr/>
            <p:nvPr/>
          </p:nvSpPr>
          <p:spPr>
            <a:xfrm>
              <a:off x="1672165" y="405378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A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D99A4976-C2A9-4027-BF05-8E720868A20C}"/>
                </a:ext>
              </a:extLst>
            </p:cNvPr>
            <p:cNvSpPr/>
            <p:nvPr/>
          </p:nvSpPr>
          <p:spPr>
            <a:xfrm>
              <a:off x="5365252" y="3429000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D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C1453784-C2D8-4016-AB03-8C248408383C}"/>
                </a:ext>
              </a:extLst>
            </p:cNvPr>
            <p:cNvSpPr/>
            <p:nvPr/>
          </p:nvSpPr>
          <p:spPr>
            <a:xfrm>
              <a:off x="1664118" y="3429000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C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2754EE69-EC9B-4CC1-BDAD-71B8558871C6}"/>
                </a:ext>
              </a:extLst>
            </p:cNvPr>
            <p:cNvSpPr/>
            <p:nvPr/>
          </p:nvSpPr>
          <p:spPr>
            <a:xfrm>
              <a:off x="5365252" y="405377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B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73AD24E3-52EE-47E0-A8F8-DA774397451D}"/>
              </a:ext>
            </a:extLst>
          </p:cNvPr>
          <p:cNvSpPr txBox="1"/>
          <p:nvPr/>
        </p:nvSpPr>
        <p:spPr>
          <a:xfrm>
            <a:off x="1735378" y="6488668"/>
            <a:ext cx="9326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-3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Raman shift 1001, 1173, 1589, 1603 cm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4-OH-tamoxifen</a:t>
            </a:r>
          </a:p>
        </p:txBody>
      </p:sp>
    </p:spTree>
    <p:extLst>
      <p:ext uri="{BB962C8B-B14F-4D97-AF65-F5344CB8AC3E}">
        <p14:creationId xmlns:p14="http://schemas.microsoft.com/office/powerpoint/2010/main" val="19903023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931DB68-FEE1-4958-B56D-D20EF416F687}"/>
              </a:ext>
            </a:extLst>
          </p:cNvPr>
          <p:cNvGrpSpPr/>
          <p:nvPr/>
        </p:nvGrpSpPr>
        <p:grpSpPr>
          <a:xfrm>
            <a:off x="2258560" y="0"/>
            <a:ext cx="7674880" cy="6142633"/>
            <a:chOff x="1434080" y="405377"/>
            <a:chExt cx="7674880" cy="614263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98A7705-4B32-4EE6-9657-A31A243CC6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71520" y="3524388"/>
              <a:ext cx="3837440" cy="302362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85E8D1D-7B33-44EC-B345-0D4E33DDBA7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4080" y="500766"/>
              <a:ext cx="3837440" cy="302362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385E947-4080-4CE0-99B3-B5C52752186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71520" y="500766"/>
              <a:ext cx="3837440" cy="302362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38D0A77-41A6-4AA8-95D5-59D02683D93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4080" y="3524388"/>
              <a:ext cx="3837440" cy="3023622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AB787F6-AA97-42EC-B252-18F857AF0244}"/>
                </a:ext>
              </a:extLst>
            </p:cNvPr>
            <p:cNvSpPr/>
            <p:nvPr/>
          </p:nvSpPr>
          <p:spPr>
            <a:xfrm>
              <a:off x="1465970" y="405378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A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942CDB0-26EF-42C8-BC03-F5BB448CB30D}"/>
                </a:ext>
              </a:extLst>
            </p:cNvPr>
            <p:cNvSpPr/>
            <p:nvPr/>
          </p:nvSpPr>
          <p:spPr>
            <a:xfrm>
              <a:off x="5159057" y="3429000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D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AFF4D72D-501A-4D8C-9592-924F5525F6ED}"/>
                </a:ext>
              </a:extLst>
            </p:cNvPr>
            <p:cNvSpPr/>
            <p:nvPr/>
          </p:nvSpPr>
          <p:spPr>
            <a:xfrm>
              <a:off x="1457923" y="3429000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C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8277B38-2AD7-43B5-9AB9-07DC4ADDE776}"/>
                </a:ext>
              </a:extLst>
            </p:cNvPr>
            <p:cNvSpPr/>
            <p:nvPr/>
          </p:nvSpPr>
          <p:spPr>
            <a:xfrm>
              <a:off x="5159057" y="405377"/>
              <a:ext cx="312847" cy="4424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2275" b="1" dirty="0">
                  <a:solidFill>
                    <a:srgbClr val="1D1C1D"/>
                  </a:solidFill>
                  <a:latin typeface="Arial" panose="020B0604020202020204" pitchFamily="34" charset="0"/>
                </a:rPr>
                <a:t>B</a:t>
              </a:r>
              <a:endParaRPr lang="en-US" sz="2275" b="1" dirty="0">
                <a:solidFill>
                  <a:srgbClr val="1D1C1D"/>
                </a:solidFill>
                <a:latin typeface="Arial" panose="020B0604020202020204" pitchFamily="34" charset="0"/>
              </a:endParaRPr>
            </a:p>
          </p:txBody>
        </p:sp>
      </p:grpSp>
      <p:sp>
        <p:nvSpPr>
          <p:cNvPr id="14" name="TextBox 10">
            <a:extLst>
              <a:ext uri="{FF2B5EF4-FFF2-40B4-BE49-F238E27FC236}">
                <a16:creationId xmlns:a16="http://schemas.microsoft.com/office/drawing/2014/main" id="{2F5BE1B1-BE0F-4EAC-8DA3-EE52764BF8F2}"/>
              </a:ext>
            </a:extLst>
          </p:cNvPr>
          <p:cNvSpPr txBox="1"/>
          <p:nvPr/>
        </p:nvSpPr>
        <p:spPr>
          <a:xfrm>
            <a:off x="1517503" y="6372033"/>
            <a:ext cx="10024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-4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Raman shift 1001, 1173, 1589, 1603 cm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methytamoxife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10717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44C746F-64C6-4AE5-927F-7EC694ED535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78"/>
          <a:stretch/>
        </p:blipFill>
        <p:spPr>
          <a:xfrm>
            <a:off x="1827902" y="1206515"/>
            <a:ext cx="7954485" cy="342451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44722D2-C230-4B04-B630-58801C7F5121}"/>
              </a:ext>
            </a:extLst>
          </p:cNvPr>
          <p:cNvSpPr txBox="1"/>
          <p:nvPr/>
        </p:nvSpPr>
        <p:spPr>
          <a:xfrm>
            <a:off x="1827902" y="5111180"/>
            <a:ext cx="853619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-5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 of the tamoxifen concentrations measured throughout the Raman spectra with the mass spectrometry.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is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Raman shift, Y axis represents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7109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7</Words>
  <Application>Microsoft Office PowerPoint</Application>
  <PresentationFormat>Widescreen</PresentationFormat>
  <Paragraphs>3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grou Zhang</dc:creator>
  <cp:lastModifiedBy>Zhang, C. (Congrou)</cp:lastModifiedBy>
  <cp:revision>2</cp:revision>
  <dcterms:created xsi:type="dcterms:W3CDTF">2024-08-20T19:43:08Z</dcterms:created>
  <dcterms:modified xsi:type="dcterms:W3CDTF">2025-07-18T09:10:18Z</dcterms:modified>
</cp:coreProperties>
</file>